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0890C-D323-441E-95C4-11B31E1792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04A15-53BB-4DDD-AEA0-763826AE1B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04CF7-5B8B-4E00-A4FF-4B2180BE0A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A4094-0AE5-4237-9BF6-2F69B8F746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ABE79-9252-459B-A225-4C3D57570D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1154B-6D8A-41B2-A6D5-1221863C17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1850F-CE0A-4FDE-B0DE-A8BC56AA04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B4456-472C-4429-8EE1-FF9121D5E1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8DBB9-CDFF-4636-B9AF-E8A3AB40A7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FA24E-E347-4F33-A902-5E9619B80F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F4A9F-249C-42CC-BC5D-E04DE476E2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C6BC4-DFFA-4D04-888D-C81965DED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2CCCD1-1DE1-4972-84AB-8E6C416D7426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3"/>
          <p:cNvSpPr/>
          <p:nvPr/>
        </p:nvSpPr>
        <p:spPr>
          <a:xfrm>
            <a:off x="5796000" y="1413000"/>
            <a:ext cx="3097080" cy="307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MolProbity Ramachandran analysis: Φ, ψ angle distributions for 303 residues from KISS1R tridimensional mode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anel A: The general case of non-Gly, non-Pro, non-prePro residues. Panel B: The Gly residues, shown with two fold symmetrized contour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anel C: The Pro residues with contour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anel D: The pre-Pro residues (excluding those that are Gly or Pro) with contour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eeMOLPROBITY (http://kinemage.biochem.duke.edu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7668000" y="260280"/>
            <a:ext cx="1180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 .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1"/>
          <p:cNvSpPr/>
          <p:nvPr/>
        </p:nvSpPr>
        <p:spPr>
          <a:xfrm>
            <a:off x="23040" y="5589720"/>
            <a:ext cx="91692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igure S1.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1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Rammachandran plots for human KISS1R tridimensional model.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tatistics, calculat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with Procheck, showed that 99.0% of the residues in the Ramachandran plot were in the mo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avored or allowed regions, and that side-chain stereo parameters were within the range of 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etter than the statistics derived from a set of crystal structures of at least 2.0 Å resolu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Image 4" descr=""/>
          <p:cNvPicPr/>
          <p:nvPr/>
        </p:nvPicPr>
        <p:blipFill>
          <a:blip r:embed="rId1"/>
          <a:srcRect l="0" t="0" r="0" b="20660"/>
          <a:stretch/>
        </p:blipFill>
        <p:spPr>
          <a:xfrm>
            <a:off x="108000" y="7920"/>
            <a:ext cx="5121360" cy="5442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6:17:10Z</dcterms:created>
  <dc:creator> Anne Mantel</dc:creator>
  <dc:description/>
  <dc:language>en-US</dc:language>
  <cp:lastModifiedBy> Anne Mantel</cp:lastModifiedBy>
  <dcterms:modified xsi:type="dcterms:W3CDTF">2012-12-11T16:17:46Z</dcterms:modified>
  <cp:revision>1</cp:revision>
  <dc:subject/>
  <dc:title>Diapositive 1</dc:title>
</cp:coreProperties>
</file>